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72" r:id="rId1"/>
  </p:sldMasterIdLst>
  <p:notesMasterIdLst>
    <p:notesMasterId r:id="rId8"/>
  </p:notesMasterIdLst>
  <p:sldIdLst>
    <p:sldId id="267" r:id="rId2"/>
    <p:sldId id="261" r:id="rId3"/>
    <p:sldId id="262" r:id="rId4"/>
    <p:sldId id="266" r:id="rId5"/>
    <p:sldId id="264" r:id="rId6"/>
    <p:sldId id="258" r:id="rId7"/>
  </p:sldIdLst>
  <p:sldSz cx="7307263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82" d="100"/>
          <a:sy n="82" d="100"/>
        </p:scale>
        <p:origin x="1224" y="-2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Relationship Id="rId4" Type="http://schemas.openxmlformats.org/officeDocument/2006/relationships/image" Target="../media/image16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6D5F2C-813C-4B27-AC5E-191681596773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03488" y="1143000"/>
            <a:ext cx="1851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BAE36D-304B-4454-8EC5-C483DB8550A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6376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7BAE36D-304B-4454-8EC5-C483DB8550AE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16052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045" y="1995312"/>
            <a:ext cx="6211174" cy="4244622"/>
          </a:xfrm>
        </p:spPr>
        <p:txBody>
          <a:bodyPr anchor="b"/>
          <a:lstStyle>
            <a:lvl1pPr algn="ctr">
              <a:defRPr sz="479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3408" y="6403623"/>
            <a:ext cx="5480447" cy="2943577"/>
          </a:xfrm>
        </p:spPr>
        <p:txBody>
          <a:bodyPr/>
          <a:lstStyle>
            <a:lvl1pPr marL="0" indent="0" algn="ctr">
              <a:buNone/>
              <a:defRPr sz="1918"/>
            </a:lvl1pPr>
            <a:lvl2pPr marL="365349" indent="0" algn="ctr">
              <a:buNone/>
              <a:defRPr sz="1598"/>
            </a:lvl2pPr>
            <a:lvl3pPr marL="730697" indent="0" algn="ctr">
              <a:buNone/>
              <a:defRPr sz="1438"/>
            </a:lvl3pPr>
            <a:lvl4pPr marL="1096046" indent="0" algn="ctr">
              <a:buNone/>
              <a:defRPr sz="1279"/>
            </a:lvl4pPr>
            <a:lvl5pPr marL="1461394" indent="0" algn="ctr">
              <a:buNone/>
              <a:defRPr sz="1279"/>
            </a:lvl5pPr>
            <a:lvl6pPr marL="1826743" indent="0" algn="ctr">
              <a:buNone/>
              <a:defRPr sz="1279"/>
            </a:lvl6pPr>
            <a:lvl7pPr marL="2192091" indent="0" algn="ctr">
              <a:buNone/>
              <a:defRPr sz="1279"/>
            </a:lvl7pPr>
            <a:lvl8pPr marL="2557440" indent="0" algn="ctr">
              <a:buNone/>
              <a:defRPr sz="1279"/>
            </a:lvl8pPr>
            <a:lvl9pPr marL="2922788" indent="0" algn="ctr">
              <a:buNone/>
              <a:defRPr sz="1279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ADB2-AB0D-4323-A8C4-38FCD55E4B54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C15C7-26EC-446C-AE4B-FAE20285BB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1734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ADB2-AB0D-4323-A8C4-38FCD55E4B54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C15C7-26EC-446C-AE4B-FAE20285BB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5126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29260" y="649111"/>
            <a:ext cx="1575629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375" y="649111"/>
            <a:ext cx="4635545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ADB2-AB0D-4323-A8C4-38FCD55E4B54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C15C7-26EC-446C-AE4B-FAE20285BB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9361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ADB2-AB0D-4323-A8C4-38FCD55E4B54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C15C7-26EC-446C-AE4B-FAE20285BB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68884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8569" y="3039537"/>
            <a:ext cx="6302514" cy="5071532"/>
          </a:xfrm>
        </p:spPr>
        <p:txBody>
          <a:bodyPr anchor="b"/>
          <a:lstStyle>
            <a:lvl1pPr>
              <a:defRPr sz="479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8569" y="8159048"/>
            <a:ext cx="6302514" cy="2666999"/>
          </a:xfrm>
        </p:spPr>
        <p:txBody>
          <a:bodyPr/>
          <a:lstStyle>
            <a:lvl1pPr marL="0" indent="0">
              <a:buNone/>
              <a:defRPr sz="1918">
                <a:solidFill>
                  <a:schemeClr val="tx1"/>
                </a:solidFill>
              </a:defRPr>
            </a:lvl1pPr>
            <a:lvl2pPr marL="365349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2pPr>
            <a:lvl3pPr marL="730697" indent="0">
              <a:buNone/>
              <a:defRPr sz="1438">
                <a:solidFill>
                  <a:schemeClr val="tx1">
                    <a:tint val="75000"/>
                  </a:schemeClr>
                </a:solidFill>
              </a:defRPr>
            </a:lvl3pPr>
            <a:lvl4pPr marL="1096046" indent="0">
              <a:buNone/>
              <a:defRPr sz="1279">
                <a:solidFill>
                  <a:schemeClr val="tx1">
                    <a:tint val="75000"/>
                  </a:schemeClr>
                </a:solidFill>
              </a:defRPr>
            </a:lvl4pPr>
            <a:lvl5pPr marL="1461394" indent="0">
              <a:buNone/>
              <a:defRPr sz="1279">
                <a:solidFill>
                  <a:schemeClr val="tx1">
                    <a:tint val="75000"/>
                  </a:schemeClr>
                </a:solidFill>
              </a:defRPr>
            </a:lvl5pPr>
            <a:lvl6pPr marL="1826743" indent="0">
              <a:buNone/>
              <a:defRPr sz="1279">
                <a:solidFill>
                  <a:schemeClr val="tx1">
                    <a:tint val="75000"/>
                  </a:schemeClr>
                </a:solidFill>
              </a:defRPr>
            </a:lvl6pPr>
            <a:lvl7pPr marL="2192091" indent="0">
              <a:buNone/>
              <a:defRPr sz="1279">
                <a:solidFill>
                  <a:schemeClr val="tx1">
                    <a:tint val="75000"/>
                  </a:schemeClr>
                </a:solidFill>
              </a:defRPr>
            </a:lvl7pPr>
            <a:lvl8pPr marL="2557440" indent="0">
              <a:buNone/>
              <a:defRPr sz="1279">
                <a:solidFill>
                  <a:schemeClr val="tx1">
                    <a:tint val="75000"/>
                  </a:schemeClr>
                </a:solidFill>
              </a:defRPr>
            </a:lvl8pPr>
            <a:lvl9pPr marL="2922788" indent="0">
              <a:buNone/>
              <a:defRPr sz="127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ADB2-AB0D-4323-A8C4-38FCD55E4B54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C15C7-26EC-446C-AE4B-FAE20285BB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91283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374" y="3245556"/>
            <a:ext cx="3105587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99302" y="3245556"/>
            <a:ext cx="3105587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ADB2-AB0D-4323-A8C4-38FCD55E4B54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C15C7-26EC-446C-AE4B-FAE20285BB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9696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326" y="649114"/>
            <a:ext cx="6302514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327" y="2988734"/>
            <a:ext cx="3091314" cy="1464732"/>
          </a:xfrm>
        </p:spPr>
        <p:txBody>
          <a:bodyPr anchor="b"/>
          <a:lstStyle>
            <a:lvl1pPr marL="0" indent="0">
              <a:buNone/>
              <a:defRPr sz="1918" b="1"/>
            </a:lvl1pPr>
            <a:lvl2pPr marL="365349" indent="0">
              <a:buNone/>
              <a:defRPr sz="1598" b="1"/>
            </a:lvl2pPr>
            <a:lvl3pPr marL="730697" indent="0">
              <a:buNone/>
              <a:defRPr sz="1438" b="1"/>
            </a:lvl3pPr>
            <a:lvl4pPr marL="1096046" indent="0">
              <a:buNone/>
              <a:defRPr sz="1279" b="1"/>
            </a:lvl4pPr>
            <a:lvl5pPr marL="1461394" indent="0">
              <a:buNone/>
              <a:defRPr sz="1279" b="1"/>
            </a:lvl5pPr>
            <a:lvl6pPr marL="1826743" indent="0">
              <a:buNone/>
              <a:defRPr sz="1279" b="1"/>
            </a:lvl6pPr>
            <a:lvl7pPr marL="2192091" indent="0">
              <a:buNone/>
              <a:defRPr sz="1279" b="1"/>
            </a:lvl7pPr>
            <a:lvl8pPr marL="2557440" indent="0">
              <a:buNone/>
              <a:defRPr sz="1279" b="1"/>
            </a:lvl8pPr>
            <a:lvl9pPr marL="2922788" indent="0">
              <a:buNone/>
              <a:defRPr sz="1279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327" y="4453467"/>
            <a:ext cx="3091314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99302" y="2988734"/>
            <a:ext cx="3106539" cy="1464732"/>
          </a:xfrm>
        </p:spPr>
        <p:txBody>
          <a:bodyPr anchor="b"/>
          <a:lstStyle>
            <a:lvl1pPr marL="0" indent="0">
              <a:buNone/>
              <a:defRPr sz="1918" b="1"/>
            </a:lvl1pPr>
            <a:lvl2pPr marL="365349" indent="0">
              <a:buNone/>
              <a:defRPr sz="1598" b="1"/>
            </a:lvl2pPr>
            <a:lvl3pPr marL="730697" indent="0">
              <a:buNone/>
              <a:defRPr sz="1438" b="1"/>
            </a:lvl3pPr>
            <a:lvl4pPr marL="1096046" indent="0">
              <a:buNone/>
              <a:defRPr sz="1279" b="1"/>
            </a:lvl4pPr>
            <a:lvl5pPr marL="1461394" indent="0">
              <a:buNone/>
              <a:defRPr sz="1279" b="1"/>
            </a:lvl5pPr>
            <a:lvl6pPr marL="1826743" indent="0">
              <a:buNone/>
              <a:defRPr sz="1279" b="1"/>
            </a:lvl6pPr>
            <a:lvl7pPr marL="2192091" indent="0">
              <a:buNone/>
              <a:defRPr sz="1279" b="1"/>
            </a:lvl7pPr>
            <a:lvl8pPr marL="2557440" indent="0">
              <a:buNone/>
              <a:defRPr sz="1279" b="1"/>
            </a:lvl8pPr>
            <a:lvl9pPr marL="2922788" indent="0">
              <a:buNone/>
              <a:defRPr sz="1279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99302" y="4453467"/>
            <a:ext cx="3106539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ADB2-AB0D-4323-A8C4-38FCD55E4B54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C15C7-26EC-446C-AE4B-FAE20285BB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2079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ADB2-AB0D-4323-A8C4-38FCD55E4B54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C15C7-26EC-446C-AE4B-FAE20285BB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6979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ADB2-AB0D-4323-A8C4-38FCD55E4B54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C15C7-26EC-446C-AE4B-FAE20285BB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0236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326" y="812800"/>
            <a:ext cx="2356783" cy="2844800"/>
          </a:xfrm>
        </p:spPr>
        <p:txBody>
          <a:bodyPr anchor="b"/>
          <a:lstStyle>
            <a:lvl1pPr>
              <a:defRPr sz="255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6538" y="1755425"/>
            <a:ext cx="3699302" cy="8664222"/>
          </a:xfrm>
        </p:spPr>
        <p:txBody>
          <a:bodyPr/>
          <a:lstStyle>
            <a:lvl1pPr>
              <a:defRPr sz="2557"/>
            </a:lvl1pPr>
            <a:lvl2pPr>
              <a:defRPr sz="2237"/>
            </a:lvl2pPr>
            <a:lvl3pPr>
              <a:defRPr sz="1918"/>
            </a:lvl3pPr>
            <a:lvl4pPr>
              <a:defRPr sz="1598"/>
            </a:lvl4pPr>
            <a:lvl5pPr>
              <a:defRPr sz="1598"/>
            </a:lvl5pPr>
            <a:lvl6pPr>
              <a:defRPr sz="1598"/>
            </a:lvl6pPr>
            <a:lvl7pPr>
              <a:defRPr sz="1598"/>
            </a:lvl7pPr>
            <a:lvl8pPr>
              <a:defRPr sz="1598"/>
            </a:lvl8pPr>
            <a:lvl9pPr>
              <a:defRPr sz="159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326" y="3657600"/>
            <a:ext cx="2356783" cy="6776156"/>
          </a:xfrm>
        </p:spPr>
        <p:txBody>
          <a:bodyPr/>
          <a:lstStyle>
            <a:lvl1pPr marL="0" indent="0">
              <a:buNone/>
              <a:defRPr sz="1279"/>
            </a:lvl1pPr>
            <a:lvl2pPr marL="365349" indent="0">
              <a:buNone/>
              <a:defRPr sz="1119"/>
            </a:lvl2pPr>
            <a:lvl3pPr marL="730697" indent="0">
              <a:buNone/>
              <a:defRPr sz="959"/>
            </a:lvl3pPr>
            <a:lvl4pPr marL="1096046" indent="0">
              <a:buNone/>
              <a:defRPr sz="799"/>
            </a:lvl4pPr>
            <a:lvl5pPr marL="1461394" indent="0">
              <a:buNone/>
              <a:defRPr sz="799"/>
            </a:lvl5pPr>
            <a:lvl6pPr marL="1826743" indent="0">
              <a:buNone/>
              <a:defRPr sz="799"/>
            </a:lvl6pPr>
            <a:lvl7pPr marL="2192091" indent="0">
              <a:buNone/>
              <a:defRPr sz="799"/>
            </a:lvl7pPr>
            <a:lvl8pPr marL="2557440" indent="0">
              <a:buNone/>
              <a:defRPr sz="799"/>
            </a:lvl8pPr>
            <a:lvl9pPr marL="2922788" indent="0">
              <a:buNone/>
              <a:defRPr sz="79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ADB2-AB0D-4323-A8C4-38FCD55E4B54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C15C7-26EC-446C-AE4B-FAE20285BB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6877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326" y="812800"/>
            <a:ext cx="2356783" cy="2844800"/>
          </a:xfrm>
        </p:spPr>
        <p:txBody>
          <a:bodyPr anchor="b"/>
          <a:lstStyle>
            <a:lvl1pPr>
              <a:defRPr sz="255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6538" y="1755425"/>
            <a:ext cx="3699302" cy="8664222"/>
          </a:xfrm>
        </p:spPr>
        <p:txBody>
          <a:bodyPr anchor="t"/>
          <a:lstStyle>
            <a:lvl1pPr marL="0" indent="0">
              <a:buNone/>
              <a:defRPr sz="2557"/>
            </a:lvl1pPr>
            <a:lvl2pPr marL="365349" indent="0">
              <a:buNone/>
              <a:defRPr sz="2237"/>
            </a:lvl2pPr>
            <a:lvl3pPr marL="730697" indent="0">
              <a:buNone/>
              <a:defRPr sz="1918"/>
            </a:lvl3pPr>
            <a:lvl4pPr marL="1096046" indent="0">
              <a:buNone/>
              <a:defRPr sz="1598"/>
            </a:lvl4pPr>
            <a:lvl5pPr marL="1461394" indent="0">
              <a:buNone/>
              <a:defRPr sz="1598"/>
            </a:lvl5pPr>
            <a:lvl6pPr marL="1826743" indent="0">
              <a:buNone/>
              <a:defRPr sz="1598"/>
            </a:lvl6pPr>
            <a:lvl7pPr marL="2192091" indent="0">
              <a:buNone/>
              <a:defRPr sz="1598"/>
            </a:lvl7pPr>
            <a:lvl8pPr marL="2557440" indent="0">
              <a:buNone/>
              <a:defRPr sz="1598"/>
            </a:lvl8pPr>
            <a:lvl9pPr marL="2922788" indent="0">
              <a:buNone/>
              <a:defRPr sz="1598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326" y="3657600"/>
            <a:ext cx="2356783" cy="6776156"/>
          </a:xfrm>
        </p:spPr>
        <p:txBody>
          <a:bodyPr/>
          <a:lstStyle>
            <a:lvl1pPr marL="0" indent="0">
              <a:buNone/>
              <a:defRPr sz="1279"/>
            </a:lvl1pPr>
            <a:lvl2pPr marL="365349" indent="0">
              <a:buNone/>
              <a:defRPr sz="1119"/>
            </a:lvl2pPr>
            <a:lvl3pPr marL="730697" indent="0">
              <a:buNone/>
              <a:defRPr sz="959"/>
            </a:lvl3pPr>
            <a:lvl4pPr marL="1096046" indent="0">
              <a:buNone/>
              <a:defRPr sz="799"/>
            </a:lvl4pPr>
            <a:lvl5pPr marL="1461394" indent="0">
              <a:buNone/>
              <a:defRPr sz="799"/>
            </a:lvl5pPr>
            <a:lvl6pPr marL="1826743" indent="0">
              <a:buNone/>
              <a:defRPr sz="799"/>
            </a:lvl6pPr>
            <a:lvl7pPr marL="2192091" indent="0">
              <a:buNone/>
              <a:defRPr sz="799"/>
            </a:lvl7pPr>
            <a:lvl8pPr marL="2557440" indent="0">
              <a:buNone/>
              <a:defRPr sz="799"/>
            </a:lvl8pPr>
            <a:lvl9pPr marL="2922788" indent="0">
              <a:buNone/>
              <a:defRPr sz="79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ADB2-AB0D-4323-A8C4-38FCD55E4B54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C15C7-26EC-446C-AE4B-FAE20285BB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796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375" y="649114"/>
            <a:ext cx="6302514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375" y="3245556"/>
            <a:ext cx="6302514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374" y="11300181"/>
            <a:ext cx="1644134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5ADB2-AB0D-4323-A8C4-38FCD55E4B54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0531" y="11300181"/>
            <a:ext cx="2466201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0755" y="11300181"/>
            <a:ext cx="1644134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0C15C7-26EC-446C-AE4B-FAE20285BBD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4437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0697" rtl="0" eaLnBrk="1" latinLnBrk="0" hangingPunct="1">
        <a:lnSpc>
          <a:spcPct val="90000"/>
        </a:lnSpc>
        <a:spcBef>
          <a:spcPct val="0"/>
        </a:spcBef>
        <a:buNone/>
        <a:defRPr sz="351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674" indent="-182674" algn="l" defTabSz="730697" rtl="0" eaLnBrk="1" latinLnBrk="0" hangingPunct="1">
        <a:lnSpc>
          <a:spcPct val="90000"/>
        </a:lnSpc>
        <a:spcBef>
          <a:spcPts val="799"/>
        </a:spcBef>
        <a:buFont typeface="Arial" panose="020B0604020202020204" pitchFamily="34" charset="0"/>
        <a:buChar char="•"/>
        <a:defRPr sz="2237" kern="1200">
          <a:solidFill>
            <a:schemeClr val="tx1"/>
          </a:solidFill>
          <a:latin typeface="+mn-lt"/>
          <a:ea typeface="+mn-ea"/>
          <a:cs typeface="+mn-cs"/>
        </a:defRPr>
      </a:lvl1pPr>
      <a:lvl2pPr marL="548023" indent="-182674" algn="l" defTabSz="730697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18" kern="1200">
          <a:solidFill>
            <a:schemeClr val="tx1"/>
          </a:solidFill>
          <a:latin typeface="+mn-lt"/>
          <a:ea typeface="+mn-ea"/>
          <a:cs typeface="+mn-cs"/>
        </a:defRPr>
      </a:lvl2pPr>
      <a:lvl3pPr marL="913371" indent="-182674" algn="l" defTabSz="730697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598" kern="1200">
          <a:solidFill>
            <a:schemeClr val="tx1"/>
          </a:solidFill>
          <a:latin typeface="+mn-lt"/>
          <a:ea typeface="+mn-ea"/>
          <a:cs typeface="+mn-cs"/>
        </a:defRPr>
      </a:lvl3pPr>
      <a:lvl4pPr marL="1278720" indent="-182674" algn="l" defTabSz="730697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38" kern="1200">
          <a:solidFill>
            <a:schemeClr val="tx1"/>
          </a:solidFill>
          <a:latin typeface="+mn-lt"/>
          <a:ea typeface="+mn-ea"/>
          <a:cs typeface="+mn-cs"/>
        </a:defRPr>
      </a:lvl4pPr>
      <a:lvl5pPr marL="1644068" indent="-182674" algn="l" defTabSz="730697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38" kern="1200">
          <a:solidFill>
            <a:schemeClr val="tx1"/>
          </a:solidFill>
          <a:latin typeface="+mn-lt"/>
          <a:ea typeface="+mn-ea"/>
          <a:cs typeface="+mn-cs"/>
        </a:defRPr>
      </a:lvl5pPr>
      <a:lvl6pPr marL="2009417" indent="-182674" algn="l" defTabSz="730697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38" kern="1200">
          <a:solidFill>
            <a:schemeClr val="tx1"/>
          </a:solidFill>
          <a:latin typeface="+mn-lt"/>
          <a:ea typeface="+mn-ea"/>
          <a:cs typeface="+mn-cs"/>
        </a:defRPr>
      </a:lvl6pPr>
      <a:lvl7pPr marL="2374765" indent="-182674" algn="l" defTabSz="730697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38" kern="1200">
          <a:solidFill>
            <a:schemeClr val="tx1"/>
          </a:solidFill>
          <a:latin typeface="+mn-lt"/>
          <a:ea typeface="+mn-ea"/>
          <a:cs typeface="+mn-cs"/>
        </a:defRPr>
      </a:lvl7pPr>
      <a:lvl8pPr marL="2740114" indent="-182674" algn="l" defTabSz="730697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38" kern="1200">
          <a:solidFill>
            <a:schemeClr val="tx1"/>
          </a:solidFill>
          <a:latin typeface="+mn-lt"/>
          <a:ea typeface="+mn-ea"/>
          <a:cs typeface="+mn-cs"/>
        </a:defRPr>
      </a:lvl8pPr>
      <a:lvl9pPr marL="3105462" indent="-182674" algn="l" defTabSz="730697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3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0697" rtl="0" eaLnBrk="1" latinLnBrk="0" hangingPunct="1">
        <a:defRPr sz="1438" kern="1200">
          <a:solidFill>
            <a:schemeClr val="tx1"/>
          </a:solidFill>
          <a:latin typeface="+mn-lt"/>
          <a:ea typeface="+mn-ea"/>
          <a:cs typeface="+mn-cs"/>
        </a:defRPr>
      </a:lvl1pPr>
      <a:lvl2pPr marL="365349" algn="l" defTabSz="730697" rtl="0" eaLnBrk="1" latinLnBrk="0" hangingPunct="1">
        <a:defRPr sz="1438" kern="1200">
          <a:solidFill>
            <a:schemeClr val="tx1"/>
          </a:solidFill>
          <a:latin typeface="+mn-lt"/>
          <a:ea typeface="+mn-ea"/>
          <a:cs typeface="+mn-cs"/>
        </a:defRPr>
      </a:lvl2pPr>
      <a:lvl3pPr marL="730697" algn="l" defTabSz="730697" rtl="0" eaLnBrk="1" latinLnBrk="0" hangingPunct="1">
        <a:defRPr sz="1438" kern="1200">
          <a:solidFill>
            <a:schemeClr val="tx1"/>
          </a:solidFill>
          <a:latin typeface="+mn-lt"/>
          <a:ea typeface="+mn-ea"/>
          <a:cs typeface="+mn-cs"/>
        </a:defRPr>
      </a:lvl3pPr>
      <a:lvl4pPr marL="1096046" algn="l" defTabSz="730697" rtl="0" eaLnBrk="1" latinLnBrk="0" hangingPunct="1">
        <a:defRPr sz="1438" kern="1200">
          <a:solidFill>
            <a:schemeClr val="tx1"/>
          </a:solidFill>
          <a:latin typeface="+mn-lt"/>
          <a:ea typeface="+mn-ea"/>
          <a:cs typeface="+mn-cs"/>
        </a:defRPr>
      </a:lvl4pPr>
      <a:lvl5pPr marL="1461394" algn="l" defTabSz="730697" rtl="0" eaLnBrk="1" latinLnBrk="0" hangingPunct="1">
        <a:defRPr sz="1438" kern="1200">
          <a:solidFill>
            <a:schemeClr val="tx1"/>
          </a:solidFill>
          <a:latin typeface="+mn-lt"/>
          <a:ea typeface="+mn-ea"/>
          <a:cs typeface="+mn-cs"/>
        </a:defRPr>
      </a:lvl5pPr>
      <a:lvl6pPr marL="1826743" algn="l" defTabSz="730697" rtl="0" eaLnBrk="1" latinLnBrk="0" hangingPunct="1">
        <a:defRPr sz="1438" kern="1200">
          <a:solidFill>
            <a:schemeClr val="tx1"/>
          </a:solidFill>
          <a:latin typeface="+mn-lt"/>
          <a:ea typeface="+mn-ea"/>
          <a:cs typeface="+mn-cs"/>
        </a:defRPr>
      </a:lvl6pPr>
      <a:lvl7pPr marL="2192091" algn="l" defTabSz="730697" rtl="0" eaLnBrk="1" latinLnBrk="0" hangingPunct="1">
        <a:defRPr sz="1438" kern="1200">
          <a:solidFill>
            <a:schemeClr val="tx1"/>
          </a:solidFill>
          <a:latin typeface="+mn-lt"/>
          <a:ea typeface="+mn-ea"/>
          <a:cs typeface="+mn-cs"/>
        </a:defRPr>
      </a:lvl7pPr>
      <a:lvl8pPr marL="2557440" algn="l" defTabSz="730697" rtl="0" eaLnBrk="1" latinLnBrk="0" hangingPunct="1">
        <a:defRPr sz="1438" kern="1200">
          <a:solidFill>
            <a:schemeClr val="tx1"/>
          </a:solidFill>
          <a:latin typeface="+mn-lt"/>
          <a:ea typeface="+mn-ea"/>
          <a:cs typeface="+mn-cs"/>
        </a:defRPr>
      </a:lvl8pPr>
      <a:lvl9pPr marL="2922788" algn="l" defTabSz="730697" rtl="0" eaLnBrk="1" latinLnBrk="0" hangingPunct="1">
        <a:defRPr sz="143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9.tiff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4.emf"/><Relationship Id="rId5" Type="http://schemas.openxmlformats.org/officeDocument/2006/relationships/oleObject" Target="../embeddings/oleObject3.bin"/><Relationship Id="rId10" Type="http://schemas.openxmlformats.org/officeDocument/2006/relationships/image" Target="../media/image16.emf"/><Relationship Id="rId4" Type="http://schemas.openxmlformats.org/officeDocument/2006/relationships/image" Target="../media/image13.emf"/><Relationship Id="rId9" Type="http://schemas.openxmlformats.org/officeDocument/2006/relationships/oleObject" Target="../embeddings/oleObject5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openxmlformats.org/officeDocument/2006/relationships/oleObject" Target="../embeddings/oleObject6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1.tif"/><Relationship Id="rId12" Type="http://schemas.openxmlformats.org/officeDocument/2006/relationships/image" Target="../media/image25.ti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0.tif"/><Relationship Id="rId11" Type="http://schemas.openxmlformats.org/officeDocument/2006/relationships/image" Target="../media/image24.tif"/><Relationship Id="rId5" Type="http://schemas.openxmlformats.org/officeDocument/2006/relationships/image" Target="../media/image19.TIF"/><Relationship Id="rId10" Type="http://schemas.openxmlformats.org/officeDocument/2006/relationships/image" Target="../media/image23.tif"/><Relationship Id="rId4" Type="http://schemas.openxmlformats.org/officeDocument/2006/relationships/image" Target="../media/image18.tiff"/><Relationship Id="rId9" Type="http://schemas.microsoft.com/office/2007/relationships/hdphoto" Target="../media/hdphoto1.wdp"/><Relationship Id="rId14" Type="http://schemas.openxmlformats.org/officeDocument/2006/relationships/image" Target="../media/image1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内容占位符 3">
            <a:extLst>
              <a:ext uri="{FF2B5EF4-FFF2-40B4-BE49-F238E27FC236}">
                <a16:creationId xmlns:a16="http://schemas.microsoft.com/office/drawing/2014/main" id="{5F603669-BF66-45A3-818A-7BFF04C2B56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03685624"/>
              </p:ext>
            </p:extLst>
          </p:nvPr>
        </p:nvGraphicFramePr>
        <p:xfrm>
          <a:off x="684688" y="2990910"/>
          <a:ext cx="6029877" cy="695991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789010">
                  <a:extLst>
                    <a:ext uri="{9D8B030D-6E8A-4147-A177-3AD203B41FA5}">
                      <a16:colId xmlns:a16="http://schemas.microsoft.com/office/drawing/2014/main" val="3054295650"/>
                    </a:ext>
                  </a:extLst>
                </a:gridCol>
                <a:gridCol w="4240867">
                  <a:extLst>
                    <a:ext uri="{9D8B030D-6E8A-4147-A177-3AD203B41FA5}">
                      <a16:colId xmlns:a16="http://schemas.microsoft.com/office/drawing/2014/main" val="613485190"/>
                    </a:ext>
                  </a:extLst>
                </a:gridCol>
              </a:tblGrid>
              <a:tr h="45510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Primer Name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Sequence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2302337"/>
                  </a:ext>
                </a:extLst>
              </a:tr>
              <a:tr h="50037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GAPDH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Forward: CAACTCCCACTCTTCCACCT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Reverse: CTTGCTCAGTGTCCTTGCTG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1356996"/>
                  </a:ext>
                </a:extLst>
              </a:tr>
              <a:tr h="50037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CCL7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Forward: GATCTCTGCCACGCTTCTGT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Reverse: TCTTGACATAGCAGCATGTGGA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5486487"/>
                  </a:ext>
                </a:extLst>
              </a:tr>
              <a:tr h="50037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OS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: TCACTGGTTTGAAACTTCTCAGC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: GAAGAGAAACTTCCAGGGGCA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9470532"/>
                  </a:ext>
                </a:extLst>
              </a:tr>
              <a:tr h="50037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6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: ACCACTTCACAAGTCGGAGG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: GCAAGTGCATCATCGTTGTTC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3349348"/>
                  </a:ext>
                </a:extLst>
              </a:tr>
              <a:tr h="50037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2A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: GAAAGTCCTGCCGGCTATCC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: GAGACTGGAATGACCCTGGC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6788420"/>
                  </a:ext>
                </a:extLst>
              </a:tr>
              <a:tr h="50037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2B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: TACACCTGCCACAAAGGAGG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: TGTTTCTTTGCACCAGCCATG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218524"/>
                  </a:ext>
                </a:extLst>
              </a:tr>
              <a:tr h="50037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 α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: CCACCACGCTCTTCTGTCTA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: TGAGGGTCTGGGCCATAGAA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1654057"/>
                  </a:ext>
                </a:extLst>
              </a:tr>
              <a:tr h="50037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06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: GCTGGCGAGCATCAAGAGTA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: TCCAGGTGAACCCCTCTGAA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8458567"/>
                  </a:ext>
                </a:extLst>
              </a:tr>
              <a:tr h="50037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g 1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: CAACACTCCCCTGACAACCA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: ACGTCTCGCAAGCCAATGTA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5380233"/>
                  </a:ext>
                </a:extLst>
              </a:tr>
              <a:tr h="50037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1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: AGATCCTCAAAGGCCCAGAA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: TCCTTTGCTGAGGAACTGGTC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23532619"/>
                  </a:ext>
                </a:extLst>
              </a:tr>
              <a:tr h="50037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2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: CTACGATGATGGTGAGCCTTG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: GATATCAGTCATGCTCTTCAGC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0449501"/>
                  </a:ext>
                </a:extLst>
              </a:tr>
              <a:tr h="50037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3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: GAAACTCTGCTGAGATGTCCCA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: AGGTTGTACGGGGTCCAAAA</a:t>
                      </a:r>
                      <a:endParaRPr lang="zh-CN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6196698"/>
                  </a:ext>
                </a:extLst>
              </a:tr>
              <a:tr h="50037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5</a:t>
                      </a:r>
                      <a:endParaRPr lang="zh-CN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: AGACATCCGTTCCCCCTACA</a:t>
                      </a:r>
                      <a:endParaRPr lang="zh-CN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: AGATGAATACCAGGGAGTAGAGTG</a:t>
                      </a:r>
                      <a:endParaRPr lang="zh-CN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7311489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9FFAEFD1-EE4E-4362-B3D2-975AF69DE2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13257" y="2312089"/>
            <a:ext cx="4746911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11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able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</a:t>
            </a:r>
            <a:r>
              <a:rPr kumimoji="0" lang="en-US" altLang="zh-CN" sz="1600" b="1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imers Sequence for </a:t>
            </a:r>
            <a:r>
              <a:rPr kumimoji="0" lang="en-US" altLang="zh-CN" sz="1600" b="1" i="0" u="none" strike="noStrike" cap="none" normalizeH="0" baseline="0" dirty="0" err="1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qRT</a:t>
            </a:r>
            <a:r>
              <a:rPr kumimoji="0" lang="en-US" altLang="zh-CN" sz="1600" b="1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PCR</a:t>
            </a:r>
            <a:endParaRPr kumimoji="0" lang="en-US" altLang="zh-CN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1250326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id="{58A68DE5-0B25-473C-B39E-23705361B79E}"/>
              </a:ext>
            </a:extLst>
          </p:cNvPr>
          <p:cNvSpPr txBox="1"/>
          <p:nvPr/>
        </p:nvSpPr>
        <p:spPr>
          <a:xfrm>
            <a:off x="40514" y="1730830"/>
            <a:ext cx="378173" cy="306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94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zh-CN" altLang="en-US" sz="139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2BE3AE05-8E98-401C-A31F-09404B843E61}"/>
              </a:ext>
            </a:extLst>
          </p:cNvPr>
          <p:cNvSpPr/>
          <p:nvPr/>
        </p:nvSpPr>
        <p:spPr>
          <a:xfrm>
            <a:off x="-78259" y="9252620"/>
            <a:ext cx="7322438" cy="18911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76200"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Figure 1 Expression of M1 markers in AAA tissues.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endParaRPr lang="zh-CN" altLang="zh-CN" sz="1600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  <a:p>
            <a:pPr marL="76200"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Expression of M1 markers (</a:t>
            </a:r>
            <a:r>
              <a:rPr lang="en-US" altLang="zh-CN" sz="1600" dirty="0" err="1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iNOS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, IL-6, IL-12A, IL-12B, TNF-</a:t>
            </a:r>
            <a:r>
              <a:rPr lang="el-GR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α) 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response to rmCCL7(100ng/ml) determined by </a:t>
            </a:r>
            <a:r>
              <a:rPr lang="en-US" altLang="zh-CN" sz="1600" dirty="0" err="1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qRT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-PCR in abdominal aortas of mice infused with either saline or Ang II (n=3-6/group)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Values were represented as mean ± SEM; Student t test was used for data analysis,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**</a:t>
            </a:r>
            <a:r>
              <a:rPr lang="en-US" altLang="zh-CN" sz="1600" i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&lt;0.01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. </a:t>
            </a:r>
            <a:endParaRPr lang="zh-CN" altLang="zh-CN" sz="1600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1BF0330-EF01-4FB9-971F-B0A7B2075024}"/>
              </a:ext>
            </a:extLst>
          </p:cNvPr>
          <p:cNvSpPr txBox="1"/>
          <p:nvPr/>
        </p:nvSpPr>
        <p:spPr>
          <a:xfrm>
            <a:off x="229600" y="6226721"/>
            <a:ext cx="378173" cy="306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94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zh-CN" altLang="en-US" sz="139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D76A5125-DD64-4255-85E2-85B1AA7ABEA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37" t="25629" r="20045" b="31160"/>
          <a:stretch/>
        </p:blipFill>
        <p:spPr>
          <a:xfrm>
            <a:off x="418686" y="1884268"/>
            <a:ext cx="2193885" cy="1832465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BA7AB8C6-F51F-490F-A808-DBB47FB9CE9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09" t="25305" r="19292" b="30946"/>
          <a:stretch/>
        </p:blipFill>
        <p:spPr>
          <a:xfrm>
            <a:off x="2710543" y="1847805"/>
            <a:ext cx="2160454" cy="1891158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7B2C0A7C-75B8-4B19-97DF-13A59289DD8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12" t="25570" r="19469" b="31299"/>
          <a:stretch/>
        </p:blipFill>
        <p:spPr>
          <a:xfrm>
            <a:off x="4968969" y="1906498"/>
            <a:ext cx="2165048" cy="1832465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AB6CB9EF-7683-4813-8280-63FD202AF35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81" t="24879" r="19936" b="30895"/>
          <a:stretch/>
        </p:blipFill>
        <p:spPr>
          <a:xfrm>
            <a:off x="418686" y="4018689"/>
            <a:ext cx="2121314" cy="1836948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07D42BAE-3052-44F0-B16F-9CD57629C08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75" t="25126" r="19574" b="30794"/>
          <a:stretch/>
        </p:blipFill>
        <p:spPr>
          <a:xfrm>
            <a:off x="2710543" y="4028476"/>
            <a:ext cx="2121314" cy="1832465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E737D004-F622-4F95-9004-28CFFDEA4E0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23" t="25125" r="20383" b="31161"/>
          <a:stretch/>
        </p:blipFill>
        <p:spPr>
          <a:xfrm>
            <a:off x="2710543" y="6104527"/>
            <a:ext cx="2121314" cy="1867005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7A75C3D9-1926-4017-B6CC-341C73D8C2C8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77" t="25701" r="19117" b="30078"/>
          <a:stretch/>
        </p:blipFill>
        <p:spPr>
          <a:xfrm>
            <a:off x="418686" y="6138213"/>
            <a:ext cx="2121314" cy="18623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9385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FF245CF4-4C14-45CC-A2EC-D9F6AC334F6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7160693"/>
              </p:ext>
            </p:extLst>
          </p:nvPr>
        </p:nvGraphicFramePr>
        <p:xfrm>
          <a:off x="3866055" y="3605370"/>
          <a:ext cx="3470275" cy="2389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84" name="Prism Project" r:id="rId3" imgW="4068000" imgH="2916000" progId="Prism5.Document">
                  <p:embed/>
                </p:oleObj>
              </mc:Choice>
              <mc:Fallback>
                <p:oleObj name="Prism Project" r:id="rId3" imgW="4068000" imgH="291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66055" y="3605370"/>
                        <a:ext cx="3470275" cy="2389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文本框 3">
            <a:extLst>
              <a:ext uri="{FF2B5EF4-FFF2-40B4-BE49-F238E27FC236}">
                <a16:creationId xmlns:a16="http://schemas.microsoft.com/office/drawing/2014/main" id="{5F2AADF1-D355-4419-BC7C-97F000E65986}"/>
              </a:ext>
            </a:extLst>
          </p:cNvPr>
          <p:cNvSpPr txBox="1"/>
          <p:nvPr/>
        </p:nvSpPr>
        <p:spPr>
          <a:xfrm>
            <a:off x="18876" y="3298334"/>
            <a:ext cx="378173" cy="306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94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zh-CN" altLang="en-US" sz="139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BD2737FD-2BAA-432C-9F45-8D8307646F06}"/>
              </a:ext>
            </a:extLst>
          </p:cNvPr>
          <p:cNvSpPr txBox="1"/>
          <p:nvPr/>
        </p:nvSpPr>
        <p:spPr>
          <a:xfrm>
            <a:off x="3677603" y="3298334"/>
            <a:ext cx="378173" cy="306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94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zh-CN" altLang="en-US" sz="139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7BA6F1BE-95A9-4970-8AAB-8DC8964A2315}"/>
              </a:ext>
            </a:extLst>
          </p:cNvPr>
          <p:cNvSpPr/>
          <p:nvPr/>
        </p:nvSpPr>
        <p:spPr>
          <a:xfrm>
            <a:off x="-18402" y="7160463"/>
            <a:ext cx="7325665" cy="22604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76200"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Figure 2 Expression of CCL7 related CCRs in BMDM and abdominal aortas. </a:t>
            </a:r>
            <a:endParaRPr lang="zh-CN" altLang="zh-CN" sz="1600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  <a:p>
            <a:pPr marL="76200"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A, 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CCR1, CCR2, CCR3, CCR5 mRNA level in BMDM incubated with rmCCL7(100ng/ml). </a:t>
            </a: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B, 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CCR1, CCR2, CCR3, CCR5 mRNA level in saline and Ang II infused abdominal aortas(n=4-8/group). Values were represented as mean ± SEM; Student t test was used for data analysis in (A, B). *</a:t>
            </a:r>
            <a:r>
              <a:rPr lang="en-US" altLang="zh-CN" sz="1600" i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P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&lt;0.05.</a:t>
            </a:r>
            <a:endParaRPr lang="zh-CN" altLang="zh-CN" sz="1600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480F9A3C-7C70-4B56-8580-6E25D38DD62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51" t="29694" r="3012" b="21389"/>
          <a:stretch/>
        </p:blipFill>
        <p:spPr>
          <a:xfrm>
            <a:off x="379186" y="3611144"/>
            <a:ext cx="3127828" cy="23199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9424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组合 30">
            <a:extLst>
              <a:ext uri="{FF2B5EF4-FFF2-40B4-BE49-F238E27FC236}">
                <a16:creationId xmlns:a16="http://schemas.microsoft.com/office/drawing/2014/main" id="{96570B9A-CC42-4423-BE98-58731298DFF9}"/>
              </a:ext>
            </a:extLst>
          </p:cNvPr>
          <p:cNvGrpSpPr/>
          <p:nvPr/>
        </p:nvGrpSpPr>
        <p:grpSpPr>
          <a:xfrm>
            <a:off x="674753" y="3172371"/>
            <a:ext cx="2946904" cy="1797409"/>
            <a:chOff x="674753" y="3172371"/>
            <a:chExt cx="2946904" cy="1797409"/>
          </a:xfrm>
        </p:grpSpPr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57077E95-DE26-4DCD-AA21-CAB66563AF55}"/>
                </a:ext>
              </a:extLst>
            </p:cNvPr>
            <p:cNvGrpSpPr/>
            <p:nvPr/>
          </p:nvGrpSpPr>
          <p:grpSpPr>
            <a:xfrm>
              <a:off x="674753" y="4448490"/>
              <a:ext cx="2946904" cy="521290"/>
              <a:chOff x="170434" y="5100326"/>
              <a:chExt cx="2848064" cy="409662"/>
            </a:xfrm>
          </p:grpSpPr>
          <p:pic>
            <p:nvPicPr>
              <p:cNvPr id="27" name="图片 26">
                <a:extLst>
                  <a:ext uri="{FF2B5EF4-FFF2-40B4-BE49-F238E27FC236}">
                    <a16:creationId xmlns:a16="http://schemas.microsoft.com/office/drawing/2014/main" id="{922FD9A1-6FE4-43D1-9D0B-6457C318DB4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943131" y="5161845"/>
                <a:ext cx="2075367" cy="31167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DA508AD5-13F9-4551-819B-66911A3EF6B2}"/>
                  </a:ext>
                </a:extLst>
              </p:cNvPr>
              <p:cNvSpPr txBox="1"/>
              <p:nvPr/>
            </p:nvSpPr>
            <p:spPr>
              <a:xfrm>
                <a:off x="170434" y="5100326"/>
                <a:ext cx="920131" cy="245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99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zh-CN" altLang="en-US" sz="996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AE27DFBA-D64B-4EE3-A0F5-1C415E45F724}"/>
                  </a:ext>
                </a:extLst>
              </p:cNvPr>
              <p:cNvSpPr txBox="1"/>
              <p:nvPr/>
            </p:nvSpPr>
            <p:spPr>
              <a:xfrm>
                <a:off x="170434" y="5294544"/>
                <a:ext cx="9201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37kDa)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227E3F59-254A-4D9A-AA93-8E33F1F850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74266" y="4007663"/>
              <a:ext cx="2147391" cy="4541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BFF297ED-8BF1-4BAB-A23A-0DCA258EF916}"/>
                </a:ext>
              </a:extLst>
            </p:cNvPr>
            <p:cNvSpPr txBox="1"/>
            <p:nvPr/>
          </p:nvSpPr>
          <p:spPr>
            <a:xfrm>
              <a:off x="711444" y="3978098"/>
              <a:ext cx="952064" cy="312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96" b="1" dirty="0">
                  <a:latin typeface="Arial" panose="020B0604020202020204" pitchFamily="34" charset="0"/>
                  <a:cs typeface="Arial" panose="020B0604020202020204" pitchFamily="34" charset="0"/>
                </a:rPr>
                <a:t>CCR1</a:t>
              </a:r>
              <a:endParaRPr lang="zh-CN" altLang="en-US" sz="996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6FD8E3E2-FD34-45F9-86BC-FB0BCF268F34}"/>
                </a:ext>
              </a:extLst>
            </p:cNvPr>
            <p:cNvSpPr txBox="1"/>
            <p:nvPr/>
          </p:nvSpPr>
          <p:spPr>
            <a:xfrm>
              <a:off x="700535" y="4166134"/>
              <a:ext cx="952064" cy="2741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43kDa)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264F30A5-369C-48BF-B89C-DA579573DCD8}"/>
                </a:ext>
              </a:extLst>
            </p:cNvPr>
            <p:cNvSpPr txBox="1"/>
            <p:nvPr/>
          </p:nvSpPr>
          <p:spPr>
            <a:xfrm>
              <a:off x="843168" y="3172371"/>
              <a:ext cx="572564" cy="312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96" dirty="0">
                  <a:latin typeface="Arial" panose="020B0604020202020204" pitchFamily="34" charset="0"/>
                  <a:cs typeface="Arial" panose="020B0604020202020204" pitchFamily="34" charset="0"/>
                </a:rPr>
                <a:t>CCL7</a:t>
              </a:r>
              <a:endParaRPr lang="zh-CN" altLang="en-US" sz="99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C773A823-2A64-418E-A8E2-593BB4DD7F15}"/>
                </a:ext>
              </a:extLst>
            </p:cNvPr>
            <p:cNvSpPr txBox="1"/>
            <p:nvPr/>
          </p:nvSpPr>
          <p:spPr>
            <a:xfrm>
              <a:off x="754085" y="3417740"/>
              <a:ext cx="778881" cy="312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96" dirty="0" err="1">
                  <a:latin typeface="Arial" panose="020B0604020202020204" pitchFamily="34" charset="0"/>
                  <a:cs typeface="Arial" panose="020B0604020202020204" pitchFamily="34" charset="0"/>
                </a:rPr>
                <a:t>Fedratinib</a:t>
              </a:r>
              <a:endParaRPr lang="zh-CN" altLang="en-US" sz="99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EDD8F33A-7FB0-4E24-96C4-DF5AAFDA54D6}"/>
                </a:ext>
              </a:extLst>
            </p:cNvPr>
            <p:cNvCxnSpPr/>
            <p:nvPr/>
          </p:nvCxnSpPr>
          <p:spPr>
            <a:xfrm>
              <a:off x="1500364" y="3966846"/>
              <a:ext cx="470775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0E5CE51D-D670-4326-A026-7BB85FD8FB00}"/>
                </a:ext>
              </a:extLst>
            </p:cNvPr>
            <p:cNvCxnSpPr/>
            <p:nvPr/>
          </p:nvCxnSpPr>
          <p:spPr>
            <a:xfrm>
              <a:off x="2077186" y="3966846"/>
              <a:ext cx="470775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id="{8F23A0EB-79B2-485F-A030-4C50FD4677E4}"/>
                </a:ext>
              </a:extLst>
            </p:cNvPr>
            <p:cNvCxnSpPr/>
            <p:nvPr/>
          </p:nvCxnSpPr>
          <p:spPr>
            <a:xfrm>
              <a:off x="2584255" y="3975428"/>
              <a:ext cx="470775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F6F1C3CE-A834-4761-A453-DC43A7D93185}"/>
                </a:ext>
              </a:extLst>
            </p:cNvPr>
            <p:cNvCxnSpPr/>
            <p:nvPr/>
          </p:nvCxnSpPr>
          <p:spPr>
            <a:xfrm>
              <a:off x="3116764" y="3975428"/>
              <a:ext cx="470775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97541324-D204-4398-BE23-7B779078CCE0}"/>
                </a:ext>
              </a:extLst>
            </p:cNvPr>
            <p:cNvSpPr txBox="1"/>
            <p:nvPr/>
          </p:nvSpPr>
          <p:spPr>
            <a:xfrm>
              <a:off x="700535" y="3665959"/>
              <a:ext cx="899271" cy="312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96" dirty="0">
                  <a:latin typeface="Arial" panose="020B0604020202020204" pitchFamily="34" charset="0"/>
                  <a:cs typeface="Arial" panose="020B0604020202020204" pitchFamily="34" charset="0"/>
                </a:rPr>
                <a:t>Fludarabine</a:t>
              </a:r>
              <a:endParaRPr lang="zh-CN" altLang="en-US" sz="99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AEAA929F-DA01-4FEB-95EB-E3A8BE7B541A}"/>
                </a:ext>
              </a:extLst>
            </p:cNvPr>
            <p:cNvSpPr txBox="1"/>
            <p:nvPr/>
          </p:nvSpPr>
          <p:spPr>
            <a:xfrm>
              <a:off x="1521181" y="3614037"/>
              <a:ext cx="470776" cy="312498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96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9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E656051F-F7DF-41BD-8E0B-17C8A0FC9CB3}"/>
                </a:ext>
              </a:extLst>
            </p:cNvPr>
            <p:cNvSpPr txBox="1"/>
            <p:nvPr/>
          </p:nvSpPr>
          <p:spPr>
            <a:xfrm>
              <a:off x="1515914" y="3422236"/>
              <a:ext cx="470776" cy="312498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96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9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169BBA60-E6CB-45D3-95E0-710F1BAD1CF3}"/>
                </a:ext>
              </a:extLst>
            </p:cNvPr>
            <p:cNvSpPr txBox="1"/>
            <p:nvPr/>
          </p:nvSpPr>
          <p:spPr>
            <a:xfrm>
              <a:off x="1502177" y="3192742"/>
              <a:ext cx="470776" cy="312498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96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9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8EAA7A63-3B0A-455F-8329-2B038EA4C8C3}"/>
                </a:ext>
              </a:extLst>
            </p:cNvPr>
            <p:cNvSpPr txBox="1"/>
            <p:nvPr/>
          </p:nvSpPr>
          <p:spPr>
            <a:xfrm>
              <a:off x="2111381" y="3648109"/>
              <a:ext cx="470776" cy="312498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96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9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45B907F0-3390-477F-A565-BED75AD5BF2E}"/>
                </a:ext>
              </a:extLst>
            </p:cNvPr>
            <p:cNvSpPr txBox="1"/>
            <p:nvPr/>
          </p:nvSpPr>
          <p:spPr>
            <a:xfrm>
              <a:off x="2619667" y="3648109"/>
              <a:ext cx="470776" cy="312498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96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9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2D79E687-000E-4B6A-8CAD-A79471A86FC9}"/>
                </a:ext>
              </a:extLst>
            </p:cNvPr>
            <p:cNvSpPr txBox="1"/>
            <p:nvPr/>
          </p:nvSpPr>
          <p:spPr>
            <a:xfrm>
              <a:off x="2098648" y="3401175"/>
              <a:ext cx="470776" cy="312498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96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9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A4177022-AA55-410B-9386-BAB182DBB2D9}"/>
                </a:ext>
              </a:extLst>
            </p:cNvPr>
            <p:cNvSpPr txBox="1"/>
            <p:nvPr/>
          </p:nvSpPr>
          <p:spPr>
            <a:xfrm>
              <a:off x="3127953" y="3387506"/>
              <a:ext cx="470776" cy="312498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96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9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6024D157-C51A-4D61-9177-10EA979C5A61}"/>
                </a:ext>
              </a:extLst>
            </p:cNvPr>
            <p:cNvSpPr txBox="1"/>
            <p:nvPr/>
          </p:nvSpPr>
          <p:spPr>
            <a:xfrm>
              <a:off x="2098648" y="3176243"/>
              <a:ext cx="470776" cy="312498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96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9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BDD329CA-609B-4D72-B8E1-0AEB6059DDA4}"/>
                </a:ext>
              </a:extLst>
            </p:cNvPr>
            <p:cNvSpPr txBox="1"/>
            <p:nvPr/>
          </p:nvSpPr>
          <p:spPr>
            <a:xfrm>
              <a:off x="2619667" y="3401175"/>
              <a:ext cx="470776" cy="312498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96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9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382FB6BE-5078-4FAF-AFE6-E464042475EB}"/>
                </a:ext>
              </a:extLst>
            </p:cNvPr>
            <p:cNvSpPr txBox="1"/>
            <p:nvPr/>
          </p:nvSpPr>
          <p:spPr>
            <a:xfrm>
              <a:off x="3131971" y="3656044"/>
              <a:ext cx="470776" cy="312498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96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9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2E4CB24C-5A35-4C86-B240-0A126A1FC561}"/>
                </a:ext>
              </a:extLst>
            </p:cNvPr>
            <p:cNvSpPr txBox="1"/>
            <p:nvPr/>
          </p:nvSpPr>
          <p:spPr>
            <a:xfrm>
              <a:off x="2616494" y="3188406"/>
              <a:ext cx="470776" cy="312498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96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9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49167D7F-2A1E-4385-85B6-AEBA42946E15}"/>
                </a:ext>
              </a:extLst>
            </p:cNvPr>
            <p:cNvSpPr txBox="1"/>
            <p:nvPr/>
          </p:nvSpPr>
          <p:spPr>
            <a:xfrm>
              <a:off x="3123936" y="3172371"/>
              <a:ext cx="470776" cy="312498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96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96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" name="矩形 29">
            <a:extLst>
              <a:ext uri="{FF2B5EF4-FFF2-40B4-BE49-F238E27FC236}">
                <a16:creationId xmlns:a16="http://schemas.microsoft.com/office/drawing/2014/main" id="{3162796A-8264-4128-B1E1-2C47271298EE}"/>
              </a:ext>
            </a:extLst>
          </p:cNvPr>
          <p:cNvSpPr/>
          <p:nvPr/>
        </p:nvSpPr>
        <p:spPr>
          <a:xfrm>
            <a:off x="0" y="7376734"/>
            <a:ext cx="7145635" cy="18933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76200"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3 The effect of JAK2 and STAT1 inhibitors on CCR1. 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otein abundance of CCR1 in BMDM incubated with rmCCL7(100ng/ml) and pretreated 1 hour with JAK2 inhibitor </a:t>
            </a:r>
            <a:r>
              <a:rPr lang="en-US" altLang="zh-CN" sz="16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edratinib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(1μM) and STAT1 inhibitor-Fludarabine (1 </a:t>
            </a:r>
            <a:r>
              <a:rPr lang="en-US" altLang="zh-CN" sz="16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μM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. Values were represented as mean ± SEM; One Way ANOVA was used for data analysis. *</a:t>
            </a:r>
            <a:r>
              <a:rPr lang="en-US" altLang="zh-CN" sz="1600" i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&lt;0.05; **</a:t>
            </a:r>
            <a:r>
              <a:rPr lang="en-US" altLang="zh-CN" sz="1600" i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&lt;0.01; respectively. </a:t>
            </a:r>
            <a:endParaRPr lang="zh-CN" altLang="zh-CN" sz="16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97ED3B84-3CAC-4FC6-8009-FC174A74D6DB}"/>
              </a:ext>
            </a:extLst>
          </p:cNvPr>
          <p:cNvSpPr txBox="1"/>
          <p:nvPr/>
        </p:nvSpPr>
        <p:spPr>
          <a:xfrm>
            <a:off x="485666" y="2436710"/>
            <a:ext cx="378173" cy="306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94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zh-CN" altLang="en-US" sz="139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38C0FA6E-BA4B-4385-8749-5AFC92589131}"/>
              </a:ext>
            </a:extLst>
          </p:cNvPr>
          <p:cNvSpPr txBox="1"/>
          <p:nvPr/>
        </p:nvSpPr>
        <p:spPr>
          <a:xfrm>
            <a:off x="4055428" y="2436709"/>
            <a:ext cx="378173" cy="306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94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zh-CN" altLang="en-US" sz="139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A948581D-29D9-4636-ABEA-AD38C1DE13F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851" r="19846" b="23763"/>
          <a:stretch/>
        </p:blipFill>
        <p:spPr>
          <a:xfrm>
            <a:off x="4511294" y="3063636"/>
            <a:ext cx="2549575" cy="19965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1193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45245C61-BF5B-44E2-9E9E-C9627FB232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2809077"/>
              </p:ext>
            </p:extLst>
          </p:nvPr>
        </p:nvGraphicFramePr>
        <p:xfrm>
          <a:off x="3425194" y="2556116"/>
          <a:ext cx="2595215" cy="25733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8" name="Prism Project" r:id="rId3" imgW="3564000" imgH="3528000" progId="Prism5.Document">
                  <p:embed/>
                </p:oleObj>
              </mc:Choice>
              <mc:Fallback>
                <p:oleObj name="Prism Project" r:id="rId3" imgW="3564000" imgH="35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25194" y="2556116"/>
                        <a:ext cx="2595215" cy="25733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7C80920E-F269-4E2D-B22C-290ADD9C51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3921515"/>
              </p:ext>
            </p:extLst>
          </p:nvPr>
        </p:nvGraphicFramePr>
        <p:xfrm>
          <a:off x="612649" y="2556116"/>
          <a:ext cx="2415844" cy="25733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9" name="Prism Project" r:id="rId5" imgW="3564000" imgH="3528000" progId="Prism5.Document">
                  <p:embed/>
                </p:oleObj>
              </mc:Choice>
              <mc:Fallback>
                <p:oleObj name="Prism Project" r:id="rId5" imgW="3564000" imgH="3528000" progId="Prism5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C4E5E2BD-74BE-467A-A022-0B6D6A29A3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12649" y="2556116"/>
                        <a:ext cx="2415844" cy="25733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9C75AB1E-CE3F-4E59-9D5F-970F5BE8D9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8595864"/>
              </p:ext>
            </p:extLst>
          </p:nvPr>
        </p:nvGraphicFramePr>
        <p:xfrm>
          <a:off x="612649" y="5129427"/>
          <a:ext cx="2474756" cy="25506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0" name="Prism Project" r:id="rId7" imgW="3564000" imgH="3528000" progId="Prism5.Document">
                  <p:embed/>
                </p:oleObj>
              </mc:Choice>
              <mc:Fallback>
                <p:oleObj name="Prism Project" r:id="rId7" imgW="3564000" imgH="3528000" progId="Prism5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E45F3A76-0D38-482C-A38A-B611F63AEA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12649" y="5129427"/>
                        <a:ext cx="2474756" cy="25506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E76AC001-F34D-4050-A0C4-8C2E60B88A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9796748"/>
              </p:ext>
            </p:extLst>
          </p:nvPr>
        </p:nvGraphicFramePr>
        <p:xfrm>
          <a:off x="3766197" y="5211681"/>
          <a:ext cx="2444407" cy="23302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1" name="Prism Project" r:id="rId9" imgW="3564000" imgH="3528000" progId="Prism5.Document">
                  <p:embed/>
                </p:oleObj>
              </mc:Choice>
              <mc:Fallback>
                <p:oleObj name="Prism Project" r:id="rId9" imgW="3564000" imgH="3528000" progId="Prism5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75CFCFA9-6AB8-4EFC-8E66-6F48C1299F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766197" y="5211681"/>
                        <a:ext cx="2444407" cy="23302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id="{DDDB4A25-D1F1-4788-8A3B-55BE72254183}"/>
              </a:ext>
            </a:extLst>
          </p:cNvPr>
          <p:cNvSpPr txBox="1"/>
          <p:nvPr/>
        </p:nvSpPr>
        <p:spPr>
          <a:xfrm>
            <a:off x="175564" y="2402675"/>
            <a:ext cx="378173" cy="306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94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zh-CN" altLang="en-US" sz="139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365D71CD-0F75-4467-A021-01CAE4E387DD}"/>
              </a:ext>
            </a:extLst>
          </p:cNvPr>
          <p:cNvSpPr/>
          <p:nvPr/>
        </p:nvSpPr>
        <p:spPr>
          <a:xfrm>
            <a:off x="166555" y="7834655"/>
            <a:ext cx="7140708" cy="27551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76200">
              <a:lnSpc>
                <a:spcPct val="200000"/>
              </a:lnSpc>
              <a:spcAft>
                <a:spcPts val="0"/>
              </a:spcAft>
            </a:pP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4 CCL7 expression in vascular related cells.</a:t>
            </a:r>
            <a:endParaRPr lang="zh-CN" altLang="zh-CN" sz="16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he level of CCL7 mRNA in vascular related cells: HUVECs(A), primary VSMCs(B), primary adventitial fibroblasts(C) and BMDMs(D), cells were incubated with Ang II(at final concentration of 100nM ,1</a:t>
            </a:r>
            <a:r>
              <a:rPr lang="zh-CN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μ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)  or TNF-</a:t>
            </a:r>
            <a:r>
              <a:rPr lang="zh-CN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α（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t final concentration of 10ng/ml</a:t>
            </a:r>
            <a:r>
              <a:rPr lang="zh-CN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）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or 24 hours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Values were represented as mean ± SEM; One Way ANOVA was used for data analysis in.**</a:t>
            </a:r>
            <a:r>
              <a:rPr lang="en-US" altLang="zh-CN" sz="1600" i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&lt;0.01; ***</a:t>
            </a:r>
            <a:r>
              <a:rPr lang="en-US" altLang="zh-CN" sz="1600" i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&lt;0.001, respectively.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7190DF00-6A21-41FC-83BF-E054DB19A928}"/>
              </a:ext>
            </a:extLst>
          </p:cNvPr>
          <p:cNvSpPr txBox="1"/>
          <p:nvPr/>
        </p:nvSpPr>
        <p:spPr>
          <a:xfrm>
            <a:off x="232648" y="5357900"/>
            <a:ext cx="378173" cy="306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94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zh-CN" altLang="en-US" sz="139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C6EB7BAA-41BE-4B0A-BC3D-BEFCBF5330FD}"/>
              </a:ext>
            </a:extLst>
          </p:cNvPr>
          <p:cNvSpPr txBox="1"/>
          <p:nvPr/>
        </p:nvSpPr>
        <p:spPr>
          <a:xfrm>
            <a:off x="3388024" y="5283991"/>
            <a:ext cx="378173" cy="306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94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endParaRPr lang="zh-CN" altLang="en-US" sz="139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370C893F-806B-4B54-81E4-69B3D3267D24}"/>
              </a:ext>
            </a:extLst>
          </p:cNvPr>
          <p:cNvSpPr txBox="1"/>
          <p:nvPr/>
        </p:nvSpPr>
        <p:spPr>
          <a:xfrm>
            <a:off x="3366282" y="2402676"/>
            <a:ext cx="378173" cy="306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94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zh-CN" altLang="en-US" sz="139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69442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70B11A9F-AA7D-4834-849D-5D086F76001A}"/>
              </a:ext>
            </a:extLst>
          </p:cNvPr>
          <p:cNvSpPr txBox="1"/>
          <p:nvPr/>
        </p:nvSpPr>
        <p:spPr>
          <a:xfrm>
            <a:off x="2763778" y="3936885"/>
            <a:ext cx="1156588" cy="2712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95" b="1" dirty="0">
                <a:latin typeface="Arial" panose="020B0604020202020204" pitchFamily="34" charset="0"/>
                <a:cs typeface="Arial" panose="020B0604020202020204" pitchFamily="34" charset="0"/>
              </a:rPr>
              <a:t>PBS </a:t>
            </a:r>
            <a:endParaRPr lang="zh-CN" altLang="en-US" sz="109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5442898-B5D1-49B7-940A-59FF1A31FA46}"/>
              </a:ext>
            </a:extLst>
          </p:cNvPr>
          <p:cNvSpPr txBox="1"/>
          <p:nvPr/>
        </p:nvSpPr>
        <p:spPr>
          <a:xfrm>
            <a:off x="5625194" y="3936885"/>
            <a:ext cx="1587608" cy="2712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95" b="1" dirty="0">
                <a:latin typeface="Arial" panose="020B0604020202020204" pitchFamily="34" charset="0"/>
                <a:cs typeface="Arial" panose="020B0604020202020204" pitchFamily="34" charset="0"/>
              </a:rPr>
              <a:t>CCL7-nAb</a:t>
            </a:r>
            <a:endParaRPr lang="zh-CN" altLang="en-US" sz="109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5BBCCD0-367D-46DC-BA95-E4AD7CDAD85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04" t="30008" r="19220" b="27004"/>
          <a:stretch/>
        </p:blipFill>
        <p:spPr>
          <a:xfrm>
            <a:off x="484027" y="891912"/>
            <a:ext cx="2603268" cy="2129430"/>
          </a:xfrm>
          <a:prstGeom prst="rect">
            <a:avLst/>
          </a:prstGeom>
        </p:spPr>
      </p:pic>
      <p:sp>
        <p:nvSpPr>
          <p:cNvPr id="35" name="文本框 34">
            <a:extLst>
              <a:ext uri="{FF2B5EF4-FFF2-40B4-BE49-F238E27FC236}">
                <a16:creationId xmlns:a16="http://schemas.microsoft.com/office/drawing/2014/main" id="{C39459A3-C07B-4715-8C6F-78D00DE2ED68}"/>
              </a:ext>
            </a:extLst>
          </p:cNvPr>
          <p:cNvSpPr txBox="1"/>
          <p:nvPr/>
        </p:nvSpPr>
        <p:spPr>
          <a:xfrm>
            <a:off x="114574" y="585033"/>
            <a:ext cx="378173" cy="306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94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zh-CN" altLang="en-US" sz="139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B4AC6BD-AAB9-4BB5-B374-0E2C170CEBAB}"/>
              </a:ext>
            </a:extLst>
          </p:cNvPr>
          <p:cNvSpPr txBox="1"/>
          <p:nvPr/>
        </p:nvSpPr>
        <p:spPr>
          <a:xfrm>
            <a:off x="3566387" y="575334"/>
            <a:ext cx="378173" cy="306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94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zh-CN" altLang="en-US" sz="139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6BC3AC84-D6AD-4D04-A1C0-EE7EEDCC9320}"/>
              </a:ext>
            </a:extLst>
          </p:cNvPr>
          <p:cNvSpPr txBox="1"/>
          <p:nvPr/>
        </p:nvSpPr>
        <p:spPr>
          <a:xfrm>
            <a:off x="2342769" y="3785040"/>
            <a:ext cx="378173" cy="306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94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endParaRPr lang="zh-CN" altLang="en-US" sz="139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CD66E31F-EBAC-4ABF-8664-E5D658F297DA}"/>
              </a:ext>
            </a:extLst>
          </p:cNvPr>
          <p:cNvSpPr txBox="1"/>
          <p:nvPr/>
        </p:nvSpPr>
        <p:spPr>
          <a:xfrm>
            <a:off x="53892" y="3765644"/>
            <a:ext cx="378173" cy="306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94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zh-CN" altLang="en-US" sz="139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305BEBF5-4FA5-4176-97E9-5AE578CB884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2573" y="839145"/>
            <a:ext cx="2256753" cy="2129430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344A3E36-F64E-46AA-8E8F-1B4BD89F33B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5505" y="4239720"/>
            <a:ext cx="1463898" cy="1213031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47" name="组合 46">
            <a:extLst>
              <a:ext uri="{FF2B5EF4-FFF2-40B4-BE49-F238E27FC236}">
                <a16:creationId xmlns:a16="http://schemas.microsoft.com/office/drawing/2014/main" id="{27AE6FA6-8948-4DA0-BD46-B2D17E9D1D24}"/>
              </a:ext>
            </a:extLst>
          </p:cNvPr>
          <p:cNvGrpSpPr/>
          <p:nvPr/>
        </p:nvGrpSpPr>
        <p:grpSpPr>
          <a:xfrm>
            <a:off x="2682985" y="4236915"/>
            <a:ext cx="1442820" cy="1221606"/>
            <a:chOff x="2620662" y="4236914"/>
            <a:chExt cx="1442820" cy="1246853"/>
          </a:xfrm>
        </p:grpSpPr>
        <p:pic>
          <p:nvPicPr>
            <p:cNvPr id="34" name="图片 33">
              <a:extLst>
                <a:ext uri="{FF2B5EF4-FFF2-40B4-BE49-F238E27FC236}">
                  <a16:creationId xmlns:a16="http://schemas.microsoft.com/office/drawing/2014/main" id="{BBA8FA6B-3991-4822-AA97-B2D365C2087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20662" y="4236914"/>
              <a:ext cx="1442820" cy="12468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45" name="直接箭头连接符 44">
              <a:extLst>
                <a:ext uri="{FF2B5EF4-FFF2-40B4-BE49-F238E27FC236}">
                  <a16:creationId xmlns:a16="http://schemas.microsoft.com/office/drawing/2014/main" id="{C1F08A6D-E1C6-4293-B436-2F98D3DBD64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28809" y="4820581"/>
              <a:ext cx="288932" cy="6356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" name="组合 47">
            <a:extLst>
              <a:ext uri="{FF2B5EF4-FFF2-40B4-BE49-F238E27FC236}">
                <a16:creationId xmlns:a16="http://schemas.microsoft.com/office/drawing/2014/main" id="{07F11F79-54E7-498E-B4BA-88AB15E2091C}"/>
              </a:ext>
            </a:extLst>
          </p:cNvPr>
          <p:cNvGrpSpPr/>
          <p:nvPr/>
        </p:nvGrpSpPr>
        <p:grpSpPr>
          <a:xfrm>
            <a:off x="4161296" y="3961260"/>
            <a:ext cx="1466496" cy="1497260"/>
            <a:chOff x="4161296" y="3961260"/>
            <a:chExt cx="1466496" cy="1497260"/>
          </a:xfrm>
        </p:grpSpPr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7471088C-DC1A-4F12-91FA-366850E84C52}"/>
                </a:ext>
              </a:extLst>
            </p:cNvPr>
            <p:cNvSpPr txBox="1"/>
            <p:nvPr/>
          </p:nvSpPr>
          <p:spPr>
            <a:xfrm>
              <a:off x="4184973" y="3961260"/>
              <a:ext cx="1442819" cy="2712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95" b="1" dirty="0">
                  <a:latin typeface="Arial" panose="020B0604020202020204" pitchFamily="34" charset="0"/>
                  <a:cs typeface="Arial" panose="020B0604020202020204" pitchFamily="34" charset="0"/>
                </a:rPr>
                <a:t>Control IgG</a:t>
              </a:r>
              <a:endParaRPr lang="zh-CN" altLang="en-US" sz="1095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E0FB5816-61AA-4C50-B309-F9E9F857FFF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61296" y="4233953"/>
              <a:ext cx="1463898" cy="122456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46" name="直接箭头连接符 45">
              <a:extLst>
                <a:ext uri="{FF2B5EF4-FFF2-40B4-BE49-F238E27FC236}">
                  <a16:creationId xmlns:a16="http://schemas.microsoft.com/office/drawing/2014/main" id="{9B5F739B-E1C0-4AC9-9442-79D7ECC1ACD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60490" y="4808764"/>
              <a:ext cx="307503" cy="7140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50" name="图片 49">
            <a:extLst>
              <a:ext uri="{FF2B5EF4-FFF2-40B4-BE49-F238E27FC236}">
                <a16:creationId xmlns:a16="http://schemas.microsoft.com/office/drawing/2014/main" id="{BF0974B1-89E6-497A-B32F-96A1161EDF08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2985" y="5538466"/>
            <a:ext cx="1442820" cy="122160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5C3E93B4-C51A-49A8-87A6-4FE8FCE4B6B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0482" y="5538467"/>
            <a:ext cx="1463898" cy="12216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B23B9117-EF0E-4A7F-9108-1DB5997BAF06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59871" y="5538466"/>
            <a:ext cx="1463898" cy="1221606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22" name="对象 21">
            <a:extLst>
              <a:ext uri="{FF2B5EF4-FFF2-40B4-BE49-F238E27FC236}">
                <a16:creationId xmlns:a16="http://schemas.microsoft.com/office/drawing/2014/main" id="{79E81888-258F-42D9-BADC-C7B1D8BA089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2212367"/>
              </p:ext>
            </p:extLst>
          </p:nvPr>
        </p:nvGraphicFramePr>
        <p:xfrm>
          <a:off x="114574" y="4304869"/>
          <a:ext cx="2406151" cy="20730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35" name="Prism Project" r:id="rId13" imgW="3636000" imgH="3132000" progId="Prism5.Document">
                  <p:embed/>
                </p:oleObj>
              </mc:Choice>
              <mc:Fallback>
                <p:oleObj name="Prism Project" r:id="rId13" imgW="3636000" imgH="3132000" progId="Prism5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FCF0B490-CCF2-4A99-BA6B-76F50A5296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14574" y="4304869"/>
                        <a:ext cx="2406151" cy="20730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矩形 1">
            <a:extLst>
              <a:ext uri="{FF2B5EF4-FFF2-40B4-BE49-F238E27FC236}">
                <a16:creationId xmlns:a16="http://schemas.microsoft.com/office/drawing/2014/main" id="{EF90C26A-A4D6-48A3-BB5E-A30975FAAA56}"/>
              </a:ext>
            </a:extLst>
          </p:cNvPr>
          <p:cNvSpPr/>
          <p:nvPr/>
        </p:nvSpPr>
        <p:spPr>
          <a:xfrm>
            <a:off x="-113546" y="8022643"/>
            <a:ext cx="7359866" cy="29991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76200"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5 Mice body weight, survival analysis and vascular remodeling.</a:t>
            </a:r>
            <a:endParaRPr lang="zh-CN" altLang="zh-CN" sz="16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  <a:p>
            <a:pPr marL="76200"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-C, 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A)Body weight, (B)Survival analysis and (C)Systolic blood pressure during the whole study (4 weeks) in PBS (n=10), Control IgG (n=10) and CCL7-nAb group (n=10) mice respectively. </a:t>
            </a: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, 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presentative images of </a:t>
            </a:r>
            <a:r>
              <a:rPr lang="en-US" altLang="zh-CN" sz="16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Verhoeff’s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Van </a:t>
            </a:r>
            <a:r>
              <a:rPr lang="en-US" altLang="zh-CN" sz="16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ieson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staining (upper panel) and Masson trichrome staining (lower panel) demonstrating elastin fragmentation and collagen deposition in PBS (n=10), Control IgG (n=10) and CCL7-nAb group (n=10), respectively. Scale bars represent 100 </a:t>
            </a:r>
            <a:r>
              <a:rPr lang="el-GR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μ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.</a:t>
            </a: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Values were represented as mean ± SEM.</a:t>
            </a:r>
            <a:endParaRPr lang="zh-CN" altLang="zh-CN" sz="16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91048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21</TotalTime>
  <Words>623</Words>
  <Application>Microsoft Office PowerPoint</Application>
  <PresentationFormat>自定义</PresentationFormat>
  <Paragraphs>90</Paragraphs>
  <Slides>6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5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rism Projec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uiping xie</dc:creator>
  <cp:lastModifiedBy>蒹葭苍苍</cp:lastModifiedBy>
  <cp:revision>76</cp:revision>
  <dcterms:created xsi:type="dcterms:W3CDTF">2021-03-04T01:35:45Z</dcterms:created>
  <dcterms:modified xsi:type="dcterms:W3CDTF">2021-06-15T13:51:20Z</dcterms:modified>
</cp:coreProperties>
</file>